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wmf" ContentType="image/x-wmf"/>
  <Override PartName="/ppt/media/image1.wmf" ContentType="image/x-wmf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242EE-FF62-46A5-84B2-796CAFB8B5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619F3-EEF6-4485-A24C-811CD6B131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C6C05-8A70-4DC5-972E-AF0479F823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FAD3A-73E9-4341-AF01-41DB9D2955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C1B67-1B87-4B48-9D3B-5A0EE0B70F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1D5EC-DCC8-4F30-828A-4BDB471C62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7192A-1B3B-4E1C-9C91-2E344D0DDB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01C72-7FD2-41C0-A496-E277ACCA47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91135-D492-44C0-80E8-A67AD8325C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CAC5C-278F-4FA2-990D-80884D7E76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C4A5C-A2E4-405C-BCA0-616AA6823A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8E20E-3D28-47D5-9D14-D9811B4C8F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38CFF2-FB95-4199-B496-AF726C3922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8.png"/><Relationship Id="rId17" Type="http://schemas.openxmlformats.org/officeDocument/2006/relationships/image" Target="../media/image19.wmf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00080" y="258840"/>
            <a:ext cx="7123320" cy="1569960"/>
            <a:chOff x="1000080" y="258840"/>
            <a:chExt cx="7123320" cy="1569960"/>
          </a:xfrm>
        </p:grpSpPr>
        <p:sp>
          <p:nvSpPr>
            <p:cNvPr id="42" name=""/>
            <p:cNvSpPr/>
            <p:nvPr/>
          </p:nvSpPr>
          <p:spPr>
            <a:xfrm>
              <a:off x="1177920" y="339840"/>
              <a:ext cx="1369800" cy="144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µg/ml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15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2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7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7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000080" y="5382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1"/>
            <a:srcRect l="5803" t="2529" r="11043" b="64789"/>
            <a:stretch/>
          </p:blipFill>
          <p:spPr>
            <a:xfrm>
              <a:off x="2367000" y="258840"/>
              <a:ext cx="5091120" cy="1569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"/>
            <p:cNvGrpSpPr/>
            <p:nvPr/>
          </p:nvGrpSpPr>
          <p:grpSpPr>
            <a:xfrm>
              <a:off x="7396200" y="959040"/>
              <a:ext cx="727200" cy="307080"/>
              <a:chOff x="7396200" y="959040"/>
              <a:chExt cx="727200" cy="307080"/>
            </a:xfrm>
          </p:grpSpPr>
          <p:sp>
            <p:nvSpPr>
              <p:cNvPr id="46" name=""/>
              <p:cNvSpPr/>
              <p:nvPr/>
            </p:nvSpPr>
            <p:spPr>
              <a:xfrm>
                <a:off x="7396200" y="1058760"/>
                <a:ext cx="88920" cy="885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7468560" y="959040"/>
                <a:ext cx="6548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ALG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48" name=""/>
          <p:cNvGrpSpPr/>
          <p:nvPr/>
        </p:nvGrpSpPr>
        <p:grpSpPr>
          <a:xfrm>
            <a:off x="1913040" y="2035080"/>
            <a:ext cx="5208480" cy="2801880"/>
            <a:chOff x="1913040" y="2035080"/>
            <a:chExt cx="5208480" cy="2801880"/>
          </a:xfrm>
        </p:grpSpPr>
        <p:sp>
          <p:nvSpPr>
            <p:cNvPr id="49" name=""/>
            <p:cNvSpPr/>
            <p:nvPr/>
          </p:nvSpPr>
          <p:spPr>
            <a:xfrm>
              <a:off x="1913040" y="213516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2"/>
            <a:stretch/>
          </p:blipFill>
          <p:spPr>
            <a:xfrm>
              <a:off x="2309760" y="2035080"/>
              <a:ext cx="4811760" cy="28018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1" name=""/>
          <p:cNvGrpSpPr/>
          <p:nvPr/>
        </p:nvGrpSpPr>
        <p:grpSpPr>
          <a:xfrm>
            <a:off x="2232000" y="5086440"/>
            <a:ext cx="4681080" cy="1468440"/>
            <a:chOff x="2232000" y="5086440"/>
            <a:chExt cx="4681080" cy="1468440"/>
          </a:xfrm>
        </p:grpSpPr>
        <p:pic>
          <p:nvPicPr>
            <p:cNvPr id="52" name="" descr=""/>
            <p:cNvPicPr/>
            <p:nvPr/>
          </p:nvPicPr>
          <p:blipFill>
            <a:blip r:embed="rId3"/>
            <a:srcRect l="3355" t="4159" r="4159" b="0"/>
            <a:stretch/>
          </p:blipFill>
          <p:spPr>
            <a:xfrm>
              <a:off x="5803920" y="5601960"/>
              <a:ext cx="704520" cy="730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4"/>
            <a:srcRect l="4949" t="5087" r="3315" b="2616"/>
            <a:stretch/>
          </p:blipFill>
          <p:spPr>
            <a:xfrm>
              <a:off x="5802120" y="5391000"/>
              <a:ext cx="707760" cy="22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5"/>
            <a:srcRect l="2505" t="0" r="5009" b="1675"/>
            <a:stretch/>
          </p:blipFill>
          <p:spPr>
            <a:xfrm>
              <a:off x="5002200" y="5587920"/>
              <a:ext cx="704520" cy="73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" descr=""/>
            <p:cNvPicPr/>
            <p:nvPr/>
          </p:nvPicPr>
          <p:blipFill>
            <a:blip r:embed="rId6"/>
            <a:srcRect l="7070" t="2432" r="5514" b="-2297"/>
            <a:stretch/>
          </p:blipFill>
          <p:spPr>
            <a:xfrm>
              <a:off x="5000400" y="5386320"/>
              <a:ext cx="707760" cy="26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" descr=""/>
            <p:cNvPicPr/>
            <p:nvPr/>
          </p:nvPicPr>
          <p:blipFill>
            <a:blip r:embed="rId7"/>
            <a:srcRect l="0" t="0" r="0" b="3399"/>
            <a:stretch/>
          </p:blipFill>
          <p:spPr>
            <a:xfrm>
              <a:off x="3898800" y="5603760"/>
              <a:ext cx="713880" cy="72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" descr=""/>
            <p:cNvPicPr/>
            <p:nvPr/>
          </p:nvPicPr>
          <p:blipFill>
            <a:blip r:embed="rId8">
              <a:lum bright="-12000"/>
            </a:blip>
            <a:srcRect l="4213" t="4730" r="862" b="-2297"/>
            <a:stretch/>
          </p:blipFill>
          <p:spPr>
            <a:xfrm>
              <a:off x="3897360" y="5391000"/>
              <a:ext cx="713880" cy="259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" descr=""/>
            <p:cNvPicPr/>
            <p:nvPr/>
          </p:nvPicPr>
          <p:blipFill>
            <a:blip r:embed="rId9"/>
            <a:srcRect l="0" t="0" r="2636" b="1675"/>
            <a:stretch/>
          </p:blipFill>
          <p:spPr>
            <a:xfrm>
              <a:off x="3116160" y="5587920"/>
              <a:ext cx="704520" cy="73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" descr=""/>
            <p:cNvPicPr/>
            <p:nvPr/>
          </p:nvPicPr>
          <p:blipFill>
            <a:blip r:embed="rId10">
              <a:lum bright="-6000"/>
            </a:blip>
            <a:srcRect l="4213" t="2616" r="2537" b="-2471"/>
            <a:stretch/>
          </p:blipFill>
          <p:spPr>
            <a:xfrm>
              <a:off x="3117600" y="5389200"/>
              <a:ext cx="701280" cy="247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"/>
            <p:cNvSpPr/>
            <p:nvPr/>
          </p:nvSpPr>
          <p:spPr>
            <a:xfrm>
              <a:off x="2520360" y="5314680"/>
              <a:ext cx="587520" cy="104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HIS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ALG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IAH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SEC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085920" y="5086440"/>
              <a:ext cx="3827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682560"/>
                  <a:tab algn="ctr" pos="25686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unicamycin (0.625 µg/m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090600" y="5338440"/>
              <a:ext cx="149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000400" y="5333760"/>
              <a:ext cx="149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101760" y="6278400"/>
              <a:ext cx="345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290520"/>
                  <a:tab algn="ctr" pos="1089000"/>
                  <a:tab algn="ctr" pos="2176560"/>
                  <a:tab algn="ctr" pos="29750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D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D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D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232000" y="521136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"/>
          <p:cNvGrpSpPr/>
          <p:nvPr/>
        </p:nvGrpSpPr>
        <p:grpSpPr>
          <a:xfrm>
            <a:off x="2627640" y="1797120"/>
            <a:ext cx="3687480" cy="3011400"/>
            <a:chOff x="2627640" y="1797120"/>
            <a:chExt cx="3687480" cy="3011400"/>
          </a:xfrm>
        </p:grpSpPr>
        <p:graphicFrame>
          <p:nvGraphicFramePr>
            <p:cNvPr id="67" name=""/>
            <p:cNvGraphicFramePr/>
            <p:nvPr/>
          </p:nvGraphicFramePr>
          <p:xfrm>
            <a:off x="5641920" y="2748240"/>
            <a:ext cx="636840" cy="20174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68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641920" y="2748240"/>
                      <a:ext cx="636840" cy="2017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9" name=""/>
            <p:cNvGraphicFramePr/>
            <p:nvPr/>
          </p:nvGraphicFramePr>
          <p:xfrm>
            <a:off x="5643720" y="2243160"/>
            <a:ext cx="633240" cy="5209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70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643720" y="2243160"/>
                      <a:ext cx="633240" cy="520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1" name=""/>
            <p:cNvGraphicFramePr/>
            <p:nvPr/>
          </p:nvGraphicFramePr>
          <p:xfrm>
            <a:off x="4910400" y="2752920"/>
            <a:ext cx="636480" cy="20160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72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910400" y="2752920"/>
                      <a:ext cx="636480" cy="2016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3" name=""/>
            <p:cNvGraphicFramePr/>
            <p:nvPr/>
          </p:nvGraphicFramePr>
          <p:xfrm>
            <a:off x="4910400" y="2243160"/>
            <a:ext cx="634680" cy="5270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74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910400" y="2243160"/>
                      <a:ext cx="634680" cy="527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5" name=""/>
            <p:cNvGraphicFramePr/>
            <p:nvPr/>
          </p:nvGraphicFramePr>
          <p:xfrm>
            <a:off x="4172040" y="2725920"/>
            <a:ext cx="638280" cy="20383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76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172040" y="2725920"/>
                      <a:ext cx="638280" cy="2038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7" name=""/>
            <p:cNvGraphicFramePr/>
            <p:nvPr/>
          </p:nvGraphicFramePr>
          <p:xfrm>
            <a:off x="4172040" y="2243160"/>
            <a:ext cx="633240" cy="51444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78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172040" y="2243160"/>
                      <a:ext cx="633240" cy="514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9" name=""/>
            <p:cNvGraphicFramePr/>
            <p:nvPr/>
          </p:nvGraphicFramePr>
          <p:xfrm>
            <a:off x="3419640" y="2756160"/>
            <a:ext cx="646200" cy="20113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80" name="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419640" y="2756160"/>
                      <a:ext cx="646200" cy="2011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1" name=""/>
            <p:cNvGraphicFramePr/>
            <p:nvPr/>
          </p:nvGraphicFramePr>
          <p:xfrm>
            <a:off x="3422880" y="2243160"/>
            <a:ext cx="642960" cy="51300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82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422880" y="2243160"/>
                      <a:ext cx="642960" cy="513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3" name=""/>
            <p:cNvSpPr/>
            <p:nvPr/>
          </p:nvSpPr>
          <p:spPr>
            <a:xfrm>
              <a:off x="2627640" y="2203560"/>
              <a:ext cx="796320" cy="2604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HIS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ORM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orf19.83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LCB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*LCB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FEN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TSC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LCB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LCB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SUR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LAC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SCS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AUR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SUR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 u="sng">
                  <a:solidFill>
                    <a:srgbClr val="000000"/>
                  </a:solidFill>
                  <a:uFillTx/>
                  <a:latin typeface="Arial"/>
                </a:rPr>
                <a:t>IPT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06960" y="1855800"/>
              <a:ext cx="300816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347760"/>
                  <a:tab algn="ctr" pos="1089000"/>
                  <a:tab algn="ctr" pos="1770120"/>
                  <a:tab algn="ctr" pos="2511360"/>
                  <a:tab algn="ctr" pos="3251160"/>
                  <a:tab algn="ctr" pos="3657600"/>
                  <a:tab algn="ctr" pos="400536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YPD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ureobasid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ctr" pos="347760"/>
                  <a:tab algn="ctr" pos="1089000"/>
                  <a:tab algn="ctr" pos="1770120"/>
                  <a:tab algn="ctr" pos="2511360"/>
                  <a:tab algn="ctr" pos="3251160"/>
                  <a:tab algn="ctr" pos="3657600"/>
                  <a:tab algn="ctr" pos="400536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 ng/ml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5 ng/ml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 ng/m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879280" y="179712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877680" y="237960"/>
            <a:ext cx="7170120" cy="1604880"/>
            <a:chOff x="877680" y="237960"/>
            <a:chExt cx="7170120" cy="1604880"/>
          </a:xfrm>
        </p:grpSpPr>
        <p:pic>
          <p:nvPicPr>
            <p:cNvPr id="87" name="" descr=""/>
            <p:cNvPicPr/>
            <p:nvPr/>
          </p:nvPicPr>
          <p:blipFill>
            <a:blip r:embed="rId17"/>
            <a:srcRect l="5803" t="1978" r="14159" b="64665"/>
            <a:stretch/>
          </p:blipFill>
          <p:spPr>
            <a:xfrm>
              <a:off x="2211120" y="237960"/>
              <a:ext cx="4899240" cy="160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>
              <a:off x="877680" y="40608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064880" y="361800"/>
              <a:ext cx="1370160" cy="144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µg/ml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01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02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85000"/>
                </a:lnSpc>
                <a:tabLst>
                  <a:tab algn="l" pos="0"/>
                  <a:tab algn="ctr" pos="345960"/>
                  <a:tab algn="ctr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06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5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"/>
            <p:cNvGrpSpPr/>
            <p:nvPr/>
          </p:nvGrpSpPr>
          <p:grpSpPr>
            <a:xfrm>
              <a:off x="7030800" y="509400"/>
              <a:ext cx="1017000" cy="1159560"/>
              <a:chOff x="7030800" y="509400"/>
              <a:chExt cx="1017000" cy="1159560"/>
            </a:xfrm>
          </p:grpSpPr>
          <p:sp>
            <p:nvSpPr>
              <p:cNvPr id="91" name=""/>
              <p:cNvSpPr/>
              <p:nvPr/>
            </p:nvSpPr>
            <p:spPr>
              <a:xfrm>
                <a:off x="7083720" y="509400"/>
                <a:ext cx="964080" cy="1159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AUR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orf19.83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ORM</a:t>
                </a: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KRE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RVB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7043400" y="1236240"/>
                <a:ext cx="109440" cy="109080"/>
              </a:xfrm>
              <a:prstGeom prst="diamond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920" bIns="7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7040160" y="610920"/>
                <a:ext cx="92160" cy="914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8000" bIns="18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7030800" y="829800"/>
                <a:ext cx="109440" cy="9972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3680" bIns="-136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7030800" y="1029960"/>
                <a:ext cx="109440" cy="99720"/>
              </a:xfrm>
              <a:prstGeom prst="triangle">
                <a:avLst>
                  <a:gd name="adj" fmla="val 50000"/>
                </a:avLst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3680" bIns="-136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7043400" y="1445760"/>
                <a:ext cx="109440" cy="109080"/>
              </a:xfrm>
              <a:prstGeom prst="diamond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920" bIns="7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7" name=""/>
          <p:cNvSpPr/>
          <p:nvPr/>
        </p:nvSpPr>
        <p:spPr>
          <a:xfrm>
            <a:off x="347760" y="4970520"/>
            <a:ext cx="851508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tunicamycin and aureobasidin A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tunicamycin at multiple ICs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Top 10 most hypersensitive strains identified in the CaFT with tunicamycin at the concentrations indicated, with z-scores greater than 4.000 highlighted in bold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with selected strains against tunicamycin. Both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I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EC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94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strains are controls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aureobasidin A, with highlighted strains: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UR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=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194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83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M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=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75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RE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=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94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VB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=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53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with heterozygous deletion strains for genes involved in sphingolipid biosynthesis against aureobasidin A. Note that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LCB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02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strain (the asterisk) was hyper-variable in the CaFT; i.e., it responded to different inhibitory compounds with no chemical structural relatedness, hence it normalized z-score was minimal (see text for detail). Note,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PT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476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strain (the underlined) was not in the CaFT strain po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1:50Z</dcterms:created>
  <dc:creator>xudemin</dc:creator>
  <dc:description/>
  <dc:language>en-US</dc:language>
  <cp:lastModifiedBy>xudemin</cp:lastModifiedBy>
  <dcterms:modified xsi:type="dcterms:W3CDTF">2007-05-17T15:20:58Z</dcterms:modified>
  <cp:revision>3</cp:revision>
  <dc:subject/>
  <dc:title>Slide 1</dc:title>
</cp:coreProperties>
</file>